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481"/>
    <p:restoredTop sz="94643"/>
  </p:normalViewPr>
  <p:slideViewPr>
    <p:cSldViewPr snapToGrid="0" snapToObjects="1">
      <p:cViewPr varScale="1">
        <p:scale>
          <a:sx n="118" d="100"/>
          <a:sy n="118" d="100"/>
        </p:scale>
        <p:origin x="224" y="3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3E4E72-F398-9B4F-8048-AFCE3F0B63C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EAA6943-7E75-9340-9CBF-AA760506F6E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6C34D3-44C2-E948-A54E-E4E66D7086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96EF4-BF44-2D48-B073-B8BF1103AAB0}" type="datetimeFigureOut">
              <a:rPr lang="en-US" smtClean="0"/>
              <a:t>9/25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759D76-8A24-6543-87E3-E044067AE1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6CADA4-62CA-634B-B984-1E44BAC812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EF2C4-CDFB-2449-84B1-9227955ADF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44850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1D6DAD-1E8B-3B4B-A556-E402070637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4A9B603-C565-0D4C-A463-B7D3159A9F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6FC078-218B-8A46-B928-D937B6D940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96EF4-BF44-2D48-B073-B8BF1103AAB0}" type="datetimeFigureOut">
              <a:rPr lang="en-US" smtClean="0"/>
              <a:t>9/25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122281-30C2-5F4A-AB0C-A48C965DD5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20D3F3-25A1-744B-9D1C-C38CCE3F71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EF2C4-CDFB-2449-84B1-9227955ADF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8739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6F744E8-4050-DF4C-8D0D-07AC4D685A6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E5B10C-4CD2-A548-BA1D-8C0256D96A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4B0426-4C77-0B46-97BC-C1D2C52C0D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96EF4-BF44-2D48-B073-B8BF1103AAB0}" type="datetimeFigureOut">
              <a:rPr lang="en-US" smtClean="0"/>
              <a:t>9/25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68CE37-5ED0-E84B-8C14-71267CBE44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37421E-A1AE-A144-8E25-4F7A900897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EF2C4-CDFB-2449-84B1-9227955ADF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489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5BC474-3A0D-734A-93F3-1D98D6D5BE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EC9FD0-610A-E246-9EF8-02EC0AA9B3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D5ABED-B31F-3E46-B920-54FF44146A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96EF4-BF44-2D48-B073-B8BF1103AAB0}" type="datetimeFigureOut">
              <a:rPr lang="en-US" smtClean="0"/>
              <a:t>9/25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4A6F5C-A25E-F846-ACAB-3423F6EF6C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3BE626-A11F-6F46-B83A-4B177A2B86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EF2C4-CDFB-2449-84B1-9227955ADF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45880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FC761F-E307-8448-9F1F-A6996A613B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1F68C37-5D31-6046-902F-66983F527B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DE491F-4854-6141-977A-6AA33BCDB4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96EF4-BF44-2D48-B073-B8BF1103AAB0}" type="datetimeFigureOut">
              <a:rPr lang="en-US" smtClean="0"/>
              <a:t>9/25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2B8A7A-3FBF-DB47-899C-79FE2C18C6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08F295-7843-BF41-95CA-9BBD415BE8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EF2C4-CDFB-2449-84B1-9227955ADF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95336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B182F6-BA6F-A746-8990-1129CD4C2C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4E6236-EDC8-5948-9587-211E28B6DB8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10C75F-4DB8-5F45-ABB2-EEA6F880D7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C3ADA2-FBF4-F342-8A5D-84ADE09492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96EF4-BF44-2D48-B073-B8BF1103AAB0}" type="datetimeFigureOut">
              <a:rPr lang="en-US" smtClean="0"/>
              <a:t>9/25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BEF1648-AE02-484A-9162-C424D122DC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259032-DCBE-D941-AA12-4C5C88E2BB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EF2C4-CDFB-2449-84B1-9227955ADF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5502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A3DE47-4211-454E-A1D5-B46764E1C4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DB93CE-A445-924F-A87F-F110DBB16B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F2667E-F8B4-2A40-9D9B-9E4AD34E84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3E63646-63AA-4340-AE02-E99C0CBA32F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5276129-B0B8-3F4F-BAFF-65F3428FAB4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A1758F0-BD64-5949-B349-4113AF9FA9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96EF4-BF44-2D48-B073-B8BF1103AAB0}" type="datetimeFigureOut">
              <a:rPr lang="en-US" smtClean="0"/>
              <a:t>9/25/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A68786E-F5B1-7448-AC43-E874863B5E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AF38E9E-4A5A-EC45-89EB-097D0C45D3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EF2C4-CDFB-2449-84B1-9227955ADF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3578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FEE3D2-CCCA-A443-9DC3-1D5440FE43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94EBE37-2144-364C-B4EB-4EC4B42FFE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96EF4-BF44-2D48-B073-B8BF1103AAB0}" type="datetimeFigureOut">
              <a:rPr lang="en-US" smtClean="0"/>
              <a:t>9/25/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F74928B-2FD3-624D-B7B5-5F63092563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DE6C57B-56DB-4341-9D82-38830F2E8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EF2C4-CDFB-2449-84B1-9227955ADF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58794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5411E58-1B6F-924F-A068-F9DAE0B631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96EF4-BF44-2D48-B073-B8BF1103AAB0}" type="datetimeFigureOut">
              <a:rPr lang="en-US" smtClean="0"/>
              <a:t>9/25/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B505D2D-A4D0-7842-9066-E0FA024083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CBAA330-1E76-2E45-B84F-9F8CF6FA7E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EF2C4-CDFB-2449-84B1-9227955ADF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377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DC315B-8FCD-D145-A3C7-DBCFC9CFC1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7517E5-AA63-C842-9EEA-982D788BD4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C947649-A3BA-024D-AC1B-53842AA672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72EC85-4A83-4F47-A16D-F188E6BF4C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96EF4-BF44-2D48-B073-B8BF1103AAB0}" type="datetimeFigureOut">
              <a:rPr lang="en-US" smtClean="0"/>
              <a:t>9/25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FF4FF2-3730-2A4A-A1F1-78C47F6279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882F505-9281-424C-9D2D-EE8E36F2A3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EF2C4-CDFB-2449-84B1-9227955ADF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87343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8218D7-28B4-3341-8003-DD30DAAD01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DB62351-29EB-CB4A-9DBA-C35CA2C1DF0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199FD3B-3972-C549-ACEC-CE79E433D2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9DAD63-92D5-284F-9B8C-1E95E734E5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96EF4-BF44-2D48-B073-B8BF1103AAB0}" type="datetimeFigureOut">
              <a:rPr lang="en-US" smtClean="0"/>
              <a:t>9/25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21EB32-7550-E441-B949-D0A3B8E396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143371-6F40-1E41-BA1F-5CC181C017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EF2C4-CDFB-2449-84B1-9227955ADF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5181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18CABC4-D987-9542-93D1-5E11C4F626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3D17B6-77FC-1B4B-AD3F-0BDD35DD38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E24BE8-4425-3B4E-A522-DB254D65D95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196EF4-BF44-2D48-B073-B8BF1103AAB0}" type="datetimeFigureOut">
              <a:rPr lang="en-US" smtClean="0"/>
              <a:t>9/25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801A1D-0D02-164F-B93B-C373236D2A5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DC09EF-017C-1649-8726-EBBFE48E49A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6EF2C4-CDFB-2449-84B1-9227955ADF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5527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gif"/><Relationship Id="rId2" Type="http://schemas.openxmlformats.org/officeDocument/2006/relationships/image" Target="../media/image3.g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gif"/><Relationship Id="rId2" Type="http://schemas.openxmlformats.org/officeDocument/2006/relationships/image" Target="../media/image5.g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4F13472-5DA5-424F-9697-34A6ED420A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48327" y="1142222"/>
            <a:ext cx="4387170" cy="307702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9585E18-0924-7242-867F-FEC107EA37B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31215" y="1142222"/>
            <a:ext cx="4407864" cy="3091543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22C24CDC-DF9B-5C43-B352-05291C995013}"/>
              </a:ext>
            </a:extLst>
          </p:cNvPr>
          <p:cNvSpPr txBox="1"/>
          <p:nvPr/>
        </p:nvSpPr>
        <p:spPr>
          <a:xfrm>
            <a:off x="3842656" y="772890"/>
            <a:ext cx="12736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Laur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9E70A70-292E-B140-8D0F-40C2FDB3B607}"/>
              </a:ext>
            </a:extLst>
          </p:cNvPr>
          <p:cNvSpPr txBox="1"/>
          <p:nvPr/>
        </p:nvSpPr>
        <p:spPr>
          <a:xfrm>
            <a:off x="8229598" y="772890"/>
            <a:ext cx="15022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Early Bir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F320A2F-E97F-F945-A6E9-EB5DABC9D840}"/>
              </a:ext>
            </a:extLst>
          </p:cNvPr>
          <p:cNvSpPr txBox="1"/>
          <p:nvPr/>
        </p:nvSpPr>
        <p:spPr>
          <a:xfrm>
            <a:off x="720271" y="2318661"/>
            <a:ext cx="1328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NPQ_L1-Ls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D6DE718-2302-C141-B341-47C94B2AF23E}"/>
              </a:ext>
            </a:extLst>
          </p:cNvPr>
          <p:cNvSpPr txBox="1"/>
          <p:nvPr/>
        </p:nvSpPr>
        <p:spPr>
          <a:xfrm>
            <a:off x="2705100" y="4947561"/>
            <a:ext cx="90805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trol and salinity treated plants from each respective genotype are randomly distributed in the measurement. Animations are a synchronized loop of five false color images from NPQ_L1, L2, L3, L4 and </a:t>
            </a:r>
            <a:r>
              <a:rPr lang="en-US" dirty="0" err="1">
                <a:solidFill>
                  <a:schemeClr val="bg1"/>
                </a:solidFill>
              </a:rPr>
              <a:t>Lss</a:t>
            </a:r>
            <a:r>
              <a:rPr lang="en-US" dirty="0">
                <a:solidFill>
                  <a:schemeClr val="bg1"/>
                </a:solidFill>
              </a:rPr>
              <a:t> measurements. We can visually compare the increase in NPQ between the two genotypes based on the color, with one genotype having distinctly higher NPQ than the other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4F045C0-45F9-744C-890F-B63F296AD087}"/>
              </a:ext>
            </a:extLst>
          </p:cNvPr>
          <p:cNvSpPr txBox="1"/>
          <p:nvPr/>
        </p:nvSpPr>
        <p:spPr>
          <a:xfrm>
            <a:off x="0" y="6581001"/>
            <a:ext cx="65131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Animations were prepared using GIMP. Start the PowerPoint slideshow to view the animation.</a:t>
            </a:r>
          </a:p>
        </p:txBody>
      </p:sp>
      <p:sp>
        <p:nvSpPr>
          <p:cNvPr id="12" name="Title 1">
            <a:extLst>
              <a:ext uri="{FF2B5EF4-FFF2-40B4-BE49-F238E27FC236}">
                <a16:creationId xmlns:a16="http://schemas.microsoft.com/office/drawing/2014/main" id="{DBAC97B4-C8F9-2F41-95A5-4D0F18EB0C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51131"/>
            <a:ext cx="12115800" cy="549101"/>
          </a:xfrm>
        </p:spPr>
        <p:txBody>
          <a:bodyPr>
            <a:normAutofit/>
          </a:bodyPr>
          <a:lstStyle/>
          <a:p>
            <a:r>
              <a:rPr lang="en-US" sz="3200" dirty="0">
                <a:solidFill>
                  <a:schemeClr val="bg1"/>
                </a:solidFill>
              </a:rPr>
              <a:t>Progression of NPQ over the course of measurement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7A95F3E-2D8A-8E47-BB1F-EA3355804E95}"/>
              </a:ext>
            </a:extLst>
          </p:cNvPr>
          <p:cNvSpPr txBox="1"/>
          <p:nvPr/>
        </p:nvSpPr>
        <p:spPr>
          <a:xfrm>
            <a:off x="6435497" y="3984320"/>
            <a:ext cx="586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B9A2565-1D60-6849-AB45-3F7D1FC96884}"/>
              </a:ext>
            </a:extLst>
          </p:cNvPr>
          <p:cNvSpPr txBox="1"/>
          <p:nvPr/>
        </p:nvSpPr>
        <p:spPr>
          <a:xfrm>
            <a:off x="6424611" y="2503327"/>
            <a:ext cx="586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3D35ED6-3B29-4746-A2E4-33471DC42F34}"/>
              </a:ext>
            </a:extLst>
          </p:cNvPr>
          <p:cNvSpPr txBox="1"/>
          <p:nvPr/>
        </p:nvSpPr>
        <p:spPr>
          <a:xfrm>
            <a:off x="6424611" y="1088862"/>
            <a:ext cx="586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4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FEDC548-04B2-264F-B4CC-812BB8599C31}"/>
              </a:ext>
            </a:extLst>
          </p:cNvPr>
          <p:cNvSpPr txBox="1"/>
          <p:nvPr/>
        </p:nvSpPr>
        <p:spPr>
          <a:xfrm>
            <a:off x="10983683" y="3984320"/>
            <a:ext cx="586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5370E82-9005-1E41-8B8E-FC85B8FD9C4E}"/>
              </a:ext>
            </a:extLst>
          </p:cNvPr>
          <p:cNvSpPr txBox="1"/>
          <p:nvPr/>
        </p:nvSpPr>
        <p:spPr>
          <a:xfrm>
            <a:off x="10972797" y="2459783"/>
            <a:ext cx="586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FD251BA-9FBB-444B-8D59-F6A74EBD4BA8}"/>
              </a:ext>
            </a:extLst>
          </p:cNvPr>
          <p:cNvSpPr txBox="1"/>
          <p:nvPr/>
        </p:nvSpPr>
        <p:spPr>
          <a:xfrm>
            <a:off x="10972797" y="1045318"/>
            <a:ext cx="586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4</a:t>
            </a:r>
          </a:p>
        </p:txBody>
      </p:sp>
    </p:spTree>
    <p:extLst>
      <p:ext uri="{BB962C8B-B14F-4D97-AF65-F5344CB8AC3E}">
        <p14:creationId xmlns:p14="http://schemas.microsoft.com/office/powerpoint/2010/main" val="18573467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1F320A2F-E97F-F945-A6E9-EB5DABC9D840}"/>
              </a:ext>
            </a:extLst>
          </p:cNvPr>
          <p:cNvSpPr txBox="1"/>
          <p:nvPr/>
        </p:nvSpPr>
        <p:spPr>
          <a:xfrm>
            <a:off x="840013" y="2351314"/>
            <a:ext cx="1328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Rfd_L1-Lss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D3FD9337-B8C2-3049-82D7-85255F9C6B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15670" y="1185761"/>
            <a:ext cx="4453870" cy="312381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171DE74C-22CF-8847-AC3E-A6D5A355C58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98558" y="1185761"/>
            <a:ext cx="4453869" cy="312381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401E69FC-7EBB-7A4F-8B95-83B32542D8CE}"/>
              </a:ext>
            </a:extLst>
          </p:cNvPr>
          <p:cNvSpPr txBox="1"/>
          <p:nvPr/>
        </p:nvSpPr>
        <p:spPr>
          <a:xfrm>
            <a:off x="3842656" y="772890"/>
            <a:ext cx="12736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Laur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CE4E496-98E2-A647-AD24-3D7B7E3955D7}"/>
              </a:ext>
            </a:extLst>
          </p:cNvPr>
          <p:cNvSpPr txBox="1"/>
          <p:nvPr/>
        </p:nvSpPr>
        <p:spPr>
          <a:xfrm>
            <a:off x="8229598" y="772890"/>
            <a:ext cx="15022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Early Bir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9980311-76D4-6744-8395-9FC9AF2922B3}"/>
              </a:ext>
            </a:extLst>
          </p:cNvPr>
          <p:cNvSpPr txBox="1"/>
          <p:nvPr/>
        </p:nvSpPr>
        <p:spPr>
          <a:xfrm>
            <a:off x="2705100" y="4947561"/>
            <a:ext cx="90805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trol and salinity treated plants from each respective genotype are randomly distributed in the measurement. Animations are a synchronized loop of five false color images from Rfd_L1, L2, L3, L4 and </a:t>
            </a:r>
            <a:r>
              <a:rPr lang="en-US" dirty="0" err="1">
                <a:solidFill>
                  <a:schemeClr val="bg1"/>
                </a:solidFill>
              </a:rPr>
              <a:t>Lss</a:t>
            </a:r>
            <a:r>
              <a:rPr lang="en-US" dirty="0">
                <a:solidFill>
                  <a:schemeClr val="bg1"/>
                </a:solidFill>
              </a:rPr>
              <a:t> measurements. We can visually compare the increase in </a:t>
            </a:r>
            <a:r>
              <a:rPr lang="en-US" dirty="0" err="1">
                <a:solidFill>
                  <a:schemeClr val="bg1"/>
                </a:solidFill>
              </a:rPr>
              <a:t>Rfd</a:t>
            </a:r>
            <a:r>
              <a:rPr lang="en-US" dirty="0">
                <a:solidFill>
                  <a:schemeClr val="bg1"/>
                </a:solidFill>
              </a:rPr>
              <a:t> between the two genotypes based on color, with one genotype having distinctly higher </a:t>
            </a:r>
            <a:r>
              <a:rPr lang="en-US" dirty="0" err="1">
                <a:solidFill>
                  <a:schemeClr val="bg1"/>
                </a:solidFill>
              </a:rPr>
              <a:t>Rfd</a:t>
            </a:r>
            <a:r>
              <a:rPr lang="en-US" dirty="0">
                <a:solidFill>
                  <a:schemeClr val="bg1"/>
                </a:solidFill>
              </a:rPr>
              <a:t> than the other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9463585-DFAF-B34A-BC64-2E0591E1CC38}"/>
              </a:ext>
            </a:extLst>
          </p:cNvPr>
          <p:cNvSpPr txBox="1"/>
          <p:nvPr/>
        </p:nvSpPr>
        <p:spPr>
          <a:xfrm>
            <a:off x="0" y="6581001"/>
            <a:ext cx="65131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Animations were prepared using GIMP. Start the PowerPoint slideshow to view the animation.</a:t>
            </a:r>
          </a:p>
        </p:txBody>
      </p:sp>
      <p:sp>
        <p:nvSpPr>
          <p:cNvPr id="9" name="Title 1">
            <a:extLst>
              <a:ext uri="{FF2B5EF4-FFF2-40B4-BE49-F238E27FC236}">
                <a16:creationId xmlns:a16="http://schemas.microsoft.com/office/drawing/2014/main" id="{96AAE65A-3862-2444-B926-D568E16F0B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51131"/>
            <a:ext cx="12115800" cy="549101"/>
          </a:xfrm>
        </p:spPr>
        <p:txBody>
          <a:bodyPr>
            <a:normAutofit/>
          </a:bodyPr>
          <a:lstStyle/>
          <a:p>
            <a:r>
              <a:rPr lang="en-US" sz="3200" dirty="0">
                <a:solidFill>
                  <a:schemeClr val="bg1"/>
                </a:solidFill>
              </a:rPr>
              <a:t>Progression of </a:t>
            </a:r>
            <a:r>
              <a:rPr lang="en-US" sz="3200" dirty="0" err="1">
                <a:solidFill>
                  <a:schemeClr val="bg1"/>
                </a:solidFill>
              </a:rPr>
              <a:t>Rfd</a:t>
            </a:r>
            <a:r>
              <a:rPr lang="en-US" sz="3200" dirty="0">
                <a:solidFill>
                  <a:schemeClr val="bg1"/>
                </a:solidFill>
              </a:rPr>
              <a:t> over the course of measuremen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CB55559-53F6-7541-A34F-2D89CE16B885}"/>
              </a:ext>
            </a:extLst>
          </p:cNvPr>
          <p:cNvSpPr txBox="1"/>
          <p:nvPr/>
        </p:nvSpPr>
        <p:spPr>
          <a:xfrm>
            <a:off x="6435497" y="3984320"/>
            <a:ext cx="586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B526803-76D5-1241-BACC-4A73E1BACA04}"/>
              </a:ext>
            </a:extLst>
          </p:cNvPr>
          <p:cNvSpPr txBox="1"/>
          <p:nvPr/>
        </p:nvSpPr>
        <p:spPr>
          <a:xfrm>
            <a:off x="6424611" y="2525099"/>
            <a:ext cx="586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2.5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35C6862-BC94-DB42-95A8-5FB95960CA67}"/>
              </a:ext>
            </a:extLst>
          </p:cNvPr>
          <p:cNvSpPr txBox="1"/>
          <p:nvPr/>
        </p:nvSpPr>
        <p:spPr>
          <a:xfrm>
            <a:off x="6424611" y="1056204"/>
            <a:ext cx="586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AEBABE5-4C43-8649-A270-23442A39EA01}"/>
              </a:ext>
            </a:extLst>
          </p:cNvPr>
          <p:cNvSpPr txBox="1"/>
          <p:nvPr/>
        </p:nvSpPr>
        <p:spPr>
          <a:xfrm>
            <a:off x="10974160" y="4036959"/>
            <a:ext cx="586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F0E2CCF-F5C7-224F-8518-F667B64B0E5F}"/>
              </a:ext>
            </a:extLst>
          </p:cNvPr>
          <p:cNvSpPr txBox="1"/>
          <p:nvPr/>
        </p:nvSpPr>
        <p:spPr>
          <a:xfrm>
            <a:off x="10963274" y="2501536"/>
            <a:ext cx="586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2.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7E0AF62-E5F4-E64C-A454-DE5EC8D0DFBE}"/>
              </a:ext>
            </a:extLst>
          </p:cNvPr>
          <p:cNvSpPr txBox="1"/>
          <p:nvPr/>
        </p:nvSpPr>
        <p:spPr>
          <a:xfrm>
            <a:off x="10963274" y="1087071"/>
            <a:ext cx="586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30276638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1F320A2F-E97F-F945-A6E9-EB5DABC9D840}"/>
              </a:ext>
            </a:extLst>
          </p:cNvPr>
          <p:cNvSpPr txBox="1"/>
          <p:nvPr/>
        </p:nvSpPr>
        <p:spPr>
          <a:xfrm>
            <a:off x="537029" y="2351314"/>
            <a:ext cx="1656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>
                <a:solidFill>
                  <a:schemeClr val="bg1"/>
                </a:solidFill>
              </a:rPr>
              <a:t>Fv</a:t>
            </a:r>
            <a:r>
              <a:rPr lang="en-US" dirty="0">
                <a:solidFill>
                  <a:schemeClr val="bg1"/>
                </a:solidFill>
              </a:rPr>
              <a:t>/Fm_L1-Ls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01E69FC-7EBB-7A4F-8B95-83B32542D8CE}"/>
              </a:ext>
            </a:extLst>
          </p:cNvPr>
          <p:cNvSpPr txBox="1"/>
          <p:nvPr/>
        </p:nvSpPr>
        <p:spPr>
          <a:xfrm>
            <a:off x="3842656" y="772890"/>
            <a:ext cx="12736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Laur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CE4E496-98E2-A647-AD24-3D7B7E3955D7}"/>
              </a:ext>
            </a:extLst>
          </p:cNvPr>
          <p:cNvSpPr txBox="1"/>
          <p:nvPr/>
        </p:nvSpPr>
        <p:spPr>
          <a:xfrm>
            <a:off x="8229598" y="772890"/>
            <a:ext cx="15022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Early Bird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A091E0E-C56E-994F-8B8A-D4024FEFF7E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26556" y="1158741"/>
            <a:ext cx="4453870" cy="312381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9A5B248-66E7-6348-9493-4499D25643C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00169" y="1142222"/>
            <a:ext cx="4454428" cy="3124201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F2DF0457-2938-5B4D-B055-71675326ECDE}"/>
              </a:ext>
            </a:extLst>
          </p:cNvPr>
          <p:cNvSpPr txBox="1"/>
          <p:nvPr/>
        </p:nvSpPr>
        <p:spPr>
          <a:xfrm>
            <a:off x="2705100" y="4947561"/>
            <a:ext cx="90805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trol and salinity treated plants from each respective genotype are randomly distributed in the measurement. Animations are a synchronized loop of five false color images from </a:t>
            </a:r>
            <a:r>
              <a:rPr lang="en-US" dirty="0" err="1">
                <a:solidFill>
                  <a:schemeClr val="bg1"/>
                </a:solidFill>
              </a:rPr>
              <a:t>Fv</a:t>
            </a:r>
            <a:r>
              <a:rPr lang="en-US" dirty="0">
                <a:solidFill>
                  <a:schemeClr val="bg1"/>
                </a:solidFill>
              </a:rPr>
              <a:t>/Fm_L1, L2, L3, L4 and </a:t>
            </a:r>
            <a:r>
              <a:rPr lang="en-US" dirty="0" err="1">
                <a:solidFill>
                  <a:schemeClr val="bg1"/>
                </a:solidFill>
              </a:rPr>
              <a:t>Lss</a:t>
            </a:r>
            <a:r>
              <a:rPr lang="en-US" dirty="0">
                <a:solidFill>
                  <a:schemeClr val="bg1"/>
                </a:solidFill>
              </a:rPr>
              <a:t> measurements. We can visually compare the decrease in </a:t>
            </a:r>
            <a:r>
              <a:rPr lang="en-US" dirty="0" err="1">
                <a:solidFill>
                  <a:schemeClr val="bg1"/>
                </a:solidFill>
              </a:rPr>
              <a:t>Fv</a:t>
            </a:r>
            <a:r>
              <a:rPr lang="en-US" dirty="0">
                <a:solidFill>
                  <a:schemeClr val="bg1"/>
                </a:solidFill>
              </a:rPr>
              <a:t>/</a:t>
            </a:r>
            <a:r>
              <a:rPr lang="en-US" dirty="0" err="1">
                <a:solidFill>
                  <a:schemeClr val="bg1"/>
                </a:solidFill>
              </a:rPr>
              <a:t>Fm</a:t>
            </a:r>
            <a:r>
              <a:rPr lang="en-US" dirty="0">
                <a:solidFill>
                  <a:schemeClr val="bg1"/>
                </a:solidFill>
              </a:rPr>
              <a:t> between the two genotypes based on the color, with one genotype having distinctly lower </a:t>
            </a:r>
            <a:r>
              <a:rPr lang="en-US" dirty="0" err="1">
                <a:solidFill>
                  <a:schemeClr val="bg1"/>
                </a:solidFill>
              </a:rPr>
              <a:t>Fv</a:t>
            </a:r>
            <a:r>
              <a:rPr lang="en-US" dirty="0">
                <a:solidFill>
                  <a:schemeClr val="bg1"/>
                </a:solidFill>
              </a:rPr>
              <a:t>/</a:t>
            </a:r>
            <a:r>
              <a:rPr lang="en-US" dirty="0" err="1">
                <a:solidFill>
                  <a:schemeClr val="bg1"/>
                </a:solidFill>
              </a:rPr>
              <a:t>Fm</a:t>
            </a:r>
            <a:r>
              <a:rPr lang="en-US" dirty="0">
                <a:solidFill>
                  <a:schemeClr val="bg1"/>
                </a:solidFill>
              </a:rPr>
              <a:t> than the other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528271F-D338-7743-A179-55EC736DB329}"/>
              </a:ext>
            </a:extLst>
          </p:cNvPr>
          <p:cNvSpPr txBox="1"/>
          <p:nvPr/>
        </p:nvSpPr>
        <p:spPr>
          <a:xfrm>
            <a:off x="-1" y="6581001"/>
            <a:ext cx="116803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Animations were prepared using GIMP. Background color for </a:t>
            </a:r>
            <a:r>
              <a:rPr lang="en-US" sz="1200" dirty="0" err="1">
                <a:solidFill>
                  <a:schemeClr val="bg1"/>
                </a:solidFill>
              </a:rPr>
              <a:t>Fv</a:t>
            </a:r>
            <a:r>
              <a:rPr lang="en-US" sz="1200" dirty="0">
                <a:solidFill>
                  <a:schemeClr val="bg1"/>
                </a:solidFill>
              </a:rPr>
              <a:t>/</a:t>
            </a:r>
            <a:r>
              <a:rPr lang="en-US" sz="1200" dirty="0" err="1">
                <a:solidFill>
                  <a:schemeClr val="bg1"/>
                </a:solidFill>
              </a:rPr>
              <a:t>Fm</a:t>
            </a:r>
            <a:r>
              <a:rPr lang="en-US" sz="1200" dirty="0">
                <a:solidFill>
                  <a:schemeClr val="bg1"/>
                </a:solidFill>
              </a:rPr>
              <a:t> pictures was changed from white/gray to black using GIMP, without affecting the </a:t>
            </a:r>
            <a:r>
              <a:rPr lang="en-US" sz="1200" dirty="0" err="1">
                <a:solidFill>
                  <a:schemeClr val="bg1"/>
                </a:solidFill>
              </a:rPr>
              <a:t>Fv</a:t>
            </a:r>
            <a:r>
              <a:rPr lang="en-US" sz="1200" dirty="0">
                <a:solidFill>
                  <a:schemeClr val="bg1"/>
                </a:solidFill>
              </a:rPr>
              <a:t>/</a:t>
            </a:r>
            <a:r>
              <a:rPr lang="en-US" sz="1200" dirty="0" err="1">
                <a:solidFill>
                  <a:schemeClr val="bg1"/>
                </a:solidFill>
              </a:rPr>
              <a:t>Fm</a:t>
            </a:r>
            <a:r>
              <a:rPr lang="en-US" sz="1200" dirty="0">
                <a:solidFill>
                  <a:schemeClr val="bg1"/>
                </a:solidFill>
              </a:rPr>
              <a:t> fluorescence signal color. </a:t>
            </a:r>
          </a:p>
        </p:txBody>
      </p:sp>
      <p:sp>
        <p:nvSpPr>
          <p:cNvPr id="9" name="Title 1">
            <a:extLst>
              <a:ext uri="{FF2B5EF4-FFF2-40B4-BE49-F238E27FC236}">
                <a16:creationId xmlns:a16="http://schemas.microsoft.com/office/drawing/2014/main" id="{652E4623-576D-C243-BDE4-CE9711A6B2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51131"/>
            <a:ext cx="12115800" cy="549101"/>
          </a:xfrm>
        </p:spPr>
        <p:txBody>
          <a:bodyPr>
            <a:normAutofit/>
          </a:bodyPr>
          <a:lstStyle/>
          <a:p>
            <a:r>
              <a:rPr lang="en-US" sz="3200" dirty="0">
                <a:solidFill>
                  <a:schemeClr val="bg1"/>
                </a:solidFill>
              </a:rPr>
              <a:t>Progression of </a:t>
            </a:r>
            <a:r>
              <a:rPr lang="en-US" sz="3200" dirty="0" err="1">
                <a:solidFill>
                  <a:schemeClr val="bg1"/>
                </a:solidFill>
              </a:rPr>
              <a:t>Fv</a:t>
            </a:r>
            <a:r>
              <a:rPr lang="en-US" sz="3200" dirty="0">
                <a:solidFill>
                  <a:schemeClr val="bg1"/>
                </a:solidFill>
              </a:rPr>
              <a:t>/</a:t>
            </a:r>
            <a:r>
              <a:rPr lang="en-US" sz="3200" dirty="0" err="1">
                <a:solidFill>
                  <a:schemeClr val="bg1"/>
                </a:solidFill>
              </a:rPr>
              <a:t>Fm</a:t>
            </a:r>
            <a:r>
              <a:rPr lang="en-US" sz="3200" dirty="0">
                <a:solidFill>
                  <a:schemeClr val="bg1"/>
                </a:solidFill>
              </a:rPr>
              <a:t> over the course of measuremen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580AB07-332C-9646-9142-4E21EABB8F68}"/>
              </a:ext>
            </a:extLst>
          </p:cNvPr>
          <p:cNvSpPr txBox="1"/>
          <p:nvPr/>
        </p:nvSpPr>
        <p:spPr>
          <a:xfrm>
            <a:off x="6435497" y="3984320"/>
            <a:ext cx="586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92F8F6C-9A74-864D-9C38-35807DDC62D7}"/>
              </a:ext>
            </a:extLst>
          </p:cNvPr>
          <p:cNvSpPr txBox="1"/>
          <p:nvPr/>
        </p:nvSpPr>
        <p:spPr>
          <a:xfrm>
            <a:off x="6424611" y="2372695"/>
            <a:ext cx="586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0.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6CB4E09-1F85-D542-9341-0421D0063C20}"/>
              </a:ext>
            </a:extLst>
          </p:cNvPr>
          <p:cNvSpPr txBox="1"/>
          <p:nvPr/>
        </p:nvSpPr>
        <p:spPr>
          <a:xfrm>
            <a:off x="6424611" y="1012660"/>
            <a:ext cx="586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0.9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FFAE448-99C0-D14B-A5A8-09BDB19E23ED}"/>
              </a:ext>
            </a:extLst>
          </p:cNvPr>
          <p:cNvSpPr txBox="1"/>
          <p:nvPr/>
        </p:nvSpPr>
        <p:spPr>
          <a:xfrm>
            <a:off x="11005456" y="3995206"/>
            <a:ext cx="586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330748B-0138-5A4A-A641-68B07BA236C5}"/>
              </a:ext>
            </a:extLst>
          </p:cNvPr>
          <p:cNvSpPr txBox="1"/>
          <p:nvPr/>
        </p:nvSpPr>
        <p:spPr>
          <a:xfrm>
            <a:off x="10994570" y="2329151"/>
            <a:ext cx="586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0.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1CC3589-32DF-6641-9416-ECEE7E7C3B85}"/>
              </a:ext>
            </a:extLst>
          </p:cNvPr>
          <p:cNvSpPr txBox="1"/>
          <p:nvPr/>
        </p:nvSpPr>
        <p:spPr>
          <a:xfrm>
            <a:off x="10994570" y="1012660"/>
            <a:ext cx="586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0.9</a:t>
            </a:r>
          </a:p>
        </p:txBody>
      </p:sp>
    </p:spTree>
    <p:extLst>
      <p:ext uri="{BB962C8B-B14F-4D97-AF65-F5344CB8AC3E}">
        <p14:creationId xmlns:p14="http://schemas.microsoft.com/office/powerpoint/2010/main" val="25592869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9</TotalTime>
  <Words>337</Words>
  <Application>Microsoft Macintosh PowerPoint</Application>
  <PresentationFormat>Widescreen</PresentationFormat>
  <Paragraphs>3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ogression of NPQ over the course of measurement</vt:lpstr>
      <vt:lpstr>Progression of Rfd over the course of measurement</vt:lpstr>
      <vt:lpstr>Progression of Fv/Fm over the course of measureme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il Adhikari</dc:creator>
  <cp:lastModifiedBy>Neil Adhikari</cp:lastModifiedBy>
  <cp:revision>49</cp:revision>
  <dcterms:created xsi:type="dcterms:W3CDTF">2019-09-16T16:09:51Z</dcterms:created>
  <dcterms:modified xsi:type="dcterms:W3CDTF">2019-09-25T17:41:07Z</dcterms:modified>
</cp:coreProperties>
</file>